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9" r:id="rId2"/>
    <p:sldId id="28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3864"/>
    <a:srgbClr val="012367"/>
    <a:srgbClr val="326FC5"/>
    <a:srgbClr val="519ABB"/>
    <a:srgbClr val="9E87C8"/>
    <a:srgbClr val="6D6D6D"/>
    <a:srgbClr val="C6C6C6"/>
    <a:srgbClr val="A7A7A7"/>
    <a:srgbClr val="76AEB3"/>
    <a:srgbClr val="E931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721" autoAdjust="0"/>
    <p:restoredTop sz="94660"/>
  </p:normalViewPr>
  <p:slideViewPr>
    <p:cSldViewPr snapToGrid="0">
      <p:cViewPr varScale="1">
        <p:scale>
          <a:sx n="60" d="100"/>
          <a:sy n="60" d="100"/>
        </p:scale>
        <p:origin x="2894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66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380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747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691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499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01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84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10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651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22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086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F2157-7C89-4D83-9331-4C24BA81FF6C}" type="datetimeFigureOut">
              <a:rPr lang="en-US" smtClean="0"/>
              <a:t>7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E23B6-93B8-4EB1-82F4-63200CCC8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76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98">
            <a:extLst>
              <a:ext uri="{FF2B5EF4-FFF2-40B4-BE49-F238E27FC236}">
                <a16:creationId xmlns:a16="http://schemas.microsoft.com/office/drawing/2014/main" id="{1A583BF8-5DBA-4E18-83AF-68F43D5C40C2}"/>
              </a:ext>
            </a:extLst>
          </p:cNvPr>
          <p:cNvSpPr txBox="1"/>
          <p:nvPr/>
        </p:nvSpPr>
        <p:spPr>
          <a:xfrm>
            <a:off x="450163" y="8571396"/>
            <a:ext cx="6028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ure S1: , Cross-cohorts analysis flowchart in HGSC vs. Norma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CDAC7A-D1AF-4349-82DF-58871483301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593" t="7860" r="32593" b="23333"/>
          <a:stretch/>
        </p:blipFill>
        <p:spPr>
          <a:xfrm>
            <a:off x="35300" y="787401"/>
            <a:ext cx="6708400" cy="745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2075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98A1CCA-FBCB-4F2A-A88D-E6F1E59CA12F}"/>
              </a:ext>
            </a:extLst>
          </p:cNvPr>
          <p:cNvSpPr txBox="1"/>
          <p:nvPr/>
        </p:nvSpPr>
        <p:spPr>
          <a:xfrm>
            <a:off x="450163" y="8571396"/>
            <a:ext cx="60282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Figure S2: Differential expression of the 22-gene panel in HGSC vs. normal tissues. Expression levels are shown as 𝑙𝑜𝑔2(𝑇𝑃𝑀+1) derived from TCGA (HGSC samples) and </a:t>
            </a:r>
            <a:r>
              <a:rPr lang="en-US" sz="1200" dirty="0" err="1"/>
              <a:t>GTEx</a:t>
            </a:r>
            <a:r>
              <a:rPr lang="en-US" sz="1200" dirty="0"/>
              <a:t> (normal ovarian tissues)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53E3E88-9F57-4677-B249-F5914F0BB8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163" y="50236"/>
            <a:ext cx="6028228" cy="8521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2949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06</TotalTime>
  <Words>54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 H-P</dc:creator>
  <cp:lastModifiedBy>R H-P</cp:lastModifiedBy>
  <cp:revision>330</cp:revision>
  <dcterms:created xsi:type="dcterms:W3CDTF">2025-11-10T18:18:45Z</dcterms:created>
  <dcterms:modified xsi:type="dcterms:W3CDTF">2026-07-08T20:44:49Z</dcterms:modified>
</cp:coreProperties>
</file>